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70" r:id="rId2"/>
    <p:sldId id="313" r:id="rId3"/>
  </p:sldIdLst>
  <p:sldSz cx="7772400" cy="10058400"/>
  <p:notesSz cx="6858000" cy="9144000"/>
  <p:custDataLst>
    <p:tags r:id="rId4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2" autoAdjust="0"/>
    <p:restoredTop sz="94660"/>
  </p:normalViewPr>
  <p:slideViewPr>
    <p:cSldViewPr snapToGrid="0">
      <p:cViewPr varScale="1">
        <p:scale>
          <a:sx n="63" d="100"/>
          <a:sy n="63" d="100"/>
        </p:scale>
        <p:origin x="256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7BD-6564-4C23-972B-21D783FC95C9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2F260-662C-4A64-8C12-8EE7055B68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1126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7BD-6564-4C23-972B-21D783FC95C9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2F260-662C-4A64-8C12-8EE7055B68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824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7BD-6564-4C23-972B-21D783FC95C9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2F260-662C-4A64-8C12-8EE7055B68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4730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7BD-6564-4C23-972B-21D783FC95C9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2F260-662C-4A64-8C12-8EE7055B68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2783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7BD-6564-4C23-972B-21D783FC95C9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2F260-662C-4A64-8C12-8EE7055B68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401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7BD-6564-4C23-972B-21D783FC95C9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2F260-662C-4A64-8C12-8EE7055B68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44999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7BD-6564-4C23-972B-21D783FC95C9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2F260-662C-4A64-8C12-8EE7055B68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9794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7BD-6564-4C23-972B-21D783FC95C9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2F260-662C-4A64-8C12-8EE7055B68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227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7BD-6564-4C23-972B-21D783FC95C9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2F260-662C-4A64-8C12-8EE7055B68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9697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7BD-6564-4C23-972B-21D783FC95C9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2F260-662C-4A64-8C12-8EE7055B68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9507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7BD-6564-4C23-972B-21D783FC95C9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2F260-662C-4A64-8C12-8EE7055B68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2844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BCB7BD-6564-4C23-972B-21D783FC95C9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F2F260-662C-4A64-8C12-8EE7055B68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6959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9248782F-D8FC-5AA5-4BE6-293C707F3529}"/>
              </a:ext>
            </a:extLst>
          </p:cNvPr>
          <p:cNvSpPr txBox="1"/>
          <p:nvPr/>
        </p:nvSpPr>
        <p:spPr>
          <a:xfrm>
            <a:off x="916686" y="4996934"/>
            <a:ext cx="5939028" cy="1902444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effectLst/>
                <a:latin typeface="MinionPro-Bold"/>
                <a:ea typeface="Calibri" panose="020F0502020204030204" pitchFamily="34" charset="0"/>
                <a:cs typeface="MinionPro-Bold"/>
              </a:rPr>
              <a:t>S1 Fig. Q1mcp qPCR assay targets within artificial positive control (APC) plasmid pLSAciHV-3-APC. 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he assay-specific primer and probe sequences and the 11 nucleotides between the assay-specific forward primer (LSBVmcpqF2) and the APC-specific probe (APC-P) are derived from the </a:t>
            </a:r>
            <a:r>
              <a:rPr lang="en-US" sz="1000" dirty="0">
                <a:latin typeface="Calibri" panose="020F0502020204030204"/>
              </a:rPr>
              <a:t>a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ipenserid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herpesvirus 3 (AciHV-3) UNR major capsid protein (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cp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) gene (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enbank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accession number OR242757.1; nucleotides 1,435 to 1,501).  The sequence of APC-P is from Snow et al (2009).  Arrows provide the relative orientation of each sequence within the plasmid pJ204 (ATUM).  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de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, restriction enzyme site; F, forward; R, reverse; P, probe.</a:t>
            </a:r>
          </a:p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000" dirty="0">
              <a:latin typeface="Calibri" panose="020F0502020204030204"/>
            </a:endParaRPr>
          </a:p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ferences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</a:t>
            </a:r>
          </a:p>
          <a:p>
            <a:pPr marL="114300" marR="0" indent="-1143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now M, McKay P, </a:t>
            </a:r>
            <a:r>
              <a:rPr lang="en-US" sz="1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tejusova</a:t>
            </a:r>
            <a:r>
              <a:rPr lang="en-U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. Development of a widely applicable positive control strategy to support detection of infectious salmon </a:t>
            </a:r>
            <a:r>
              <a:rPr lang="en-US" sz="1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emia</a:t>
            </a:r>
            <a:r>
              <a:rPr lang="en-U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virus (ISAV) using </a:t>
            </a:r>
            <a:r>
              <a:rPr lang="en-US" sz="1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qman</a:t>
            </a:r>
            <a:r>
              <a:rPr lang="en-U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al-time PCR. J Fish Dis. 2009; 32: 151−156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B7B1721-7C23-BA43-0D01-97AD99A4CC49}"/>
              </a:ext>
            </a:extLst>
          </p:cNvPr>
          <p:cNvSpPr txBox="1"/>
          <p:nvPr/>
        </p:nvSpPr>
        <p:spPr>
          <a:xfrm>
            <a:off x="916686" y="7062894"/>
            <a:ext cx="5939028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0" i="1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Any use of trade, firm, or product names is for descriptive purposes only and does not imply endorsement by the U.S. Government.</a:t>
            </a:r>
            <a:r>
              <a:rPr lang="en-US" sz="800" dirty="0"/>
              <a:t>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7C97C86-4B61-1ACC-172E-ED3C82ABF2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9112" y="1928293"/>
            <a:ext cx="6734175" cy="2981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32279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extBox 53">
            <a:extLst>
              <a:ext uri="{FF2B5EF4-FFF2-40B4-BE49-F238E27FC236}">
                <a16:creationId xmlns:a16="http://schemas.microsoft.com/office/drawing/2014/main" id="{F588E816-BF2F-7072-FF09-2E0182C978EF}"/>
              </a:ext>
            </a:extLst>
          </p:cNvPr>
          <p:cNvSpPr txBox="1"/>
          <p:nvPr/>
        </p:nvSpPr>
        <p:spPr>
          <a:xfrm>
            <a:off x="54381" y="2865837"/>
            <a:ext cx="7663638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MinionPro-Bold"/>
                <a:ea typeface="Calibri" panose="020F0502020204030204" pitchFamily="34" charset="0"/>
                <a:cs typeface="MinionPro-Bold"/>
              </a:rPr>
              <a:t>S1 Fig. Q1mcp qPCR assay targets within artificial positive control (APC) plasmid pLSAciHV-3-APC. 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he assay-specific primer and probe sequences and the 11 nucleotides between the assay-specific forward primer (LSBVmcpqF2) and the APC-specific probe (APC-P) are derived from the </a:t>
            </a:r>
            <a:r>
              <a:rPr lang="en-US" sz="1000" dirty="0">
                <a:solidFill>
                  <a:prstClr val="black"/>
                </a:solidFill>
                <a:latin typeface="Calibri" panose="020F0502020204030204"/>
              </a:rPr>
              <a:t>a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ipenserid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herpesvirus 3 (AciHV-3) 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UNR major capsid protein (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cp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) gene (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enbank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accession number OR242757.1; nucleotides 1,435 to 1,501).  The sequence of APC-P is from Snow et al (2009).  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rrows provide the relative orientation of each sequence within the plasmid pJ204 (ATUM).  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de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, restriction enzyme site; F, forward; R, reverse; P, probe.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7A65E773-C8E4-5714-153A-2F46D875AE65}"/>
              </a:ext>
            </a:extLst>
          </p:cNvPr>
          <p:cNvSpPr/>
          <p:nvPr/>
        </p:nvSpPr>
        <p:spPr>
          <a:xfrm>
            <a:off x="273590" y="2249122"/>
            <a:ext cx="1537600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CA" sz="1000" cap="all" dirty="0"/>
              <a:t>GTCGCCGAAATCACCTTGA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2AB8323E-2FC9-86C6-3431-49353C811328}"/>
              </a:ext>
            </a:extLst>
          </p:cNvPr>
          <p:cNvSpPr/>
          <p:nvPr/>
        </p:nvSpPr>
        <p:spPr>
          <a:xfrm>
            <a:off x="1966568" y="2249122"/>
            <a:ext cx="138371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sz="1000" cap="all" dirty="0" err="1"/>
              <a:t>accgtctagcatccagt</a:t>
            </a:r>
            <a:endParaRPr lang="en-CA" sz="1000" cap="all" dirty="0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E28E3C6F-7A0C-3816-EAB7-F9436018076D}"/>
              </a:ext>
            </a:extLst>
          </p:cNvPr>
          <p:cNvSpPr/>
          <p:nvPr/>
        </p:nvSpPr>
        <p:spPr>
          <a:xfrm>
            <a:off x="3216702" y="2249122"/>
            <a:ext cx="1281120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CA" sz="1000" cap="all" dirty="0"/>
              <a:t>AGGTACGGCAACCAC</a:t>
            </a: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54E8D0B0-2079-248F-E151-C4E7B3DDDF8C}"/>
              </a:ext>
            </a:extLst>
          </p:cNvPr>
          <p:cNvSpPr/>
          <p:nvPr/>
        </p:nvSpPr>
        <p:spPr>
          <a:xfrm>
            <a:off x="4615202" y="2249122"/>
            <a:ext cx="155523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sz="1000" cap="all" dirty="0"/>
              <a:t>GAGATGTTCGACGCCACCA</a:t>
            </a:r>
          </a:p>
        </p:txBody>
      </p: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47025CDF-71DD-8F07-330E-AC1C3E013D10}"/>
              </a:ext>
            </a:extLst>
          </p:cNvPr>
          <p:cNvCxnSpPr/>
          <p:nvPr/>
        </p:nvCxnSpPr>
        <p:spPr>
          <a:xfrm>
            <a:off x="394834" y="2273459"/>
            <a:ext cx="134455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Rectangle 61">
            <a:extLst>
              <a:ext uri="{FF2B5EF4-FFF2-40B4-BE49-F238E27FC236}">
                <a16:creationId xmlns:a16="http://schemas.microsoft.com/office/drawing/2014/main" id="{205C9E37-4E85-1AEC-AFD5-78210FCF10DA}"/>
              </a:ext>
            </a:extLst>
          </p:cNvPr>
          <p:cNvSpPr/>
          <p:nvPr/>
        </p:nvSpPr>
        <p:spPr>
          <a:xfrm>
            <a:off x="668645" y="2068999"/>
            <a:ext cx="857927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CA" sz="1000" dirty="0"/>
              <a:t>LSBVmcpqF2</a:t>
            </a:r>
          </a:p>
        </p:txBody>
      </p: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25582103-5D9A-06E2-9468-D59172CF564A}"/>
              </a:ext>
            </a:extLst>
          </p:cNvPr>
          <p:cNvCxnSpPr/>
          <p:nvPr/>
        </p:nvCxnSpPr>
        <p:spPr>
          <a:xfrm>
            <a:off x="2078287" y="2273459"/>
            <a:ext cx="1161288" cy="0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Rectangle 63">
            <a:extLst>
              <a:ext uri="{FF2B5EF4-FFF2-40B4-BE49-F238E27FC236}">
                <a16:creationId xmlns:a16="http://schemas.microsoft.com/office/drawing/2014/main" id="{8D317452-9848-BD30-EB60-80A2E82404E4}"/>
              </a:ext>
            </a:extLst>
          </p:cNvPr>
          <p:cNvSpPr/>
          <p:nvPr/>
        </p:nvSpPr>
        <p:spPr>
          <a:xfrm>
            <a:off x="2403326" y="2068999"/>
            <a:ext cx="497252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CA" sz="1000" dirty="0"/>
              <a:t>APC-P</a:t>
            </a:r>
          </a:p>
        </p:txBody>
      </p: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A8D157AF-C96E-1821-AD8F-07072B17F8D8}"/>
              </a:ext>
            </a:extLst>
          </p:cNvPr>
          <p:cNvCxnSpPr/>
          <p:nvPr/>
        </p:nvCxnSpPr>
        <p:spPr>
          <a:xfrm>
            <a:off x="3329704" y="2273459"/>
            <a:ext cx="1069848" cy="0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Rectangle 65">
            <a:extLst>
              <a:ext uri="{FF2B5EF4-FFF2-40B4-BE49-F238E27FC236}">
                <a16:creationId xmlns:a16="http://schemas.microsoft.com/office/drawing/2014/main" id="{FB59756C-8896-F90A-6545-93DD95F70DC0}"/>
              </a:ext>
            </a:extLst>
          </p:cNvPr>
          <p:cNvSpPr/>
          <p:nvPr/>
        </p:nvSpPr>
        <p:spPr>
          <a:xfrm>
            <a:off x="3461279" y="2068999"/>
            <a:ext cx="864339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CA" sz="1000" dirty="0"/>
              <a:t>LSBVmcpqP2</a:t>
            </a:r>
          </a:p>
        </p:txBody>
      </p: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D9DAC78F-FAD2-3262-4608-6703C70A9789}"/>
              </a:ext>
            </a:extLst>
          </p:cNvPr>
          <p:cNvCxnSpPr/>
          <p:nvPr/>
        </p:nvCxnSpPr>
        <p:spPr>
          <a:xfrm flipH="1">
            <a:off x="4725034" y="2273459"/>
            <a:ext cx="1316736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Rectangle 67">
            <a:extLst>
              <a:ext uri="{FF2B5EF4-FFF2-40B4-BE49-F238E27FC236}">
                <a16:creationId xmlns:a16="http://schemas.microsoft.com/office/drawing/2014/main" id="{8E66E3C1-F4AE-10FD-B808-F7B54094C9BB}"/>
              </a:ext>
            </a:extLst>
          </p:cNvPr>
          <p:cNvSpPr/>
          <p:nvPr/>
        </p:nvSpPr>
        <p:spPr>
          <a:xfrm>
            <a:off x="4950219" y="2068999"/>
            <a:ext cx="867545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CA" sz="1000" dirty="0"/>
              <a:t>LSBVmcpqR2</a:t>
            </a: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FD730E43-74FC-C1A7-FAD3-AD865EDC4DC6}"/>
              </a:ext>
            </a:extLst>
          </p:cNvPr>
          <p:cNvSpPr/>
          <p:nvPr/>
        </p:nvSpPr>
        <p:spPr>
          <a:xfrm>
            <a:off x="1723703" y="2249122"/>
            <a:ext cx="35458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sz="1000" cap="all" dirty="0"/>
              <a:t>N</a:t>
            </a:r>
            <a:r>
              <a:rPr lang="en-CA" sz="1000" cap="all" baseline="-25000" dirty="0"/>
              <a:t>11</a:t>
            </a: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21318BA2-E24A-EB46-AD4F-114205313390}"/>
              </a:ext>
            </a:extLst>
          </p:cNvPr>
          <p:cNvSpPr/>
          <p:nvPr/>
        </p:nvSpPr>
        <p:spPr>
          <a:xfrm>
            <a:off x="4361488" y="2249122"/>
            <a:ext cx="38985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sz="1000" cap="all" dirty="0" err="1"/>
              <a:t>Cct</a:t>
            </a:r>
            <a:endParaRPr lang="en-CA" sz="1000" cap="all" dirty="0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3F0F6637-46F1-4901-6BF4-47CB89F4DDC7}"/>
              </a:ext>
            </a:extLst>
          </p:cNvPr>
          <p:cNvSpPr/>
          <p:nvPr/>
        </p:nvSpPr>
        <p:spPr>
          <a:xfrm>
            <a:off x="6030389" y="2249122"/>
            <a:ext cx="83548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sz="1000" cap="all" dirty="0"/>
              <a:t>CACGAGCAT</a:t>
            </a: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C03E6200-E3E3-0D5E-09AF-3C8DF2938F9C}"/>
              </a:ext>
            </a:extLst>
          </p:cNvPr>
          <p:cNvSpPr/>
          <p:nvPr/>
        </p:nvSpPr>
        <p:spPr>
          <a:xfrm>
            <a:off x="6738426" y="2249122"/>
            <a:ext cx="6062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sz="1000" cap="all" dirty="0"/>
              <a:t>CATATG</a:t>
            </a: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983FF8C3-5B30-E2F9-540E-A1CF569E0ED3}"/>
              </a:ext>
            </a:extLst>
          </p:cNvPr>
          <p:cNvSpPr/>
          <p:nvPr/>
        </p:nvSpPr>
        <p:spPr>
          <a:xfrm>
            <a:off x="6837011" y="2078524"/>
            <a:ext cx="426720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CA" sz="1000" i="1" dirty="0" err="1"/>
              <a:t>Nde</a:t>
            </a:r>
            <a:r>
              <a:rPr lang="en-CA" sz="1000" dirty="0" err="1"/>
              <a:t>I</a:t>
            </a:r>
            <a:endParaRPr lang="en-CA" sz="1000" dirty="0"/>
          </a:p>
        </p:txBody>
      </p:sp>
    </p:spTree>
    <p:extLst>
      <p:ext uri="{BB962C8B-B14F-4D97-AF65-F5344CB8AC3E}">
        <p14:creationId xmlns:p14="http://schemas.microsoft.com/office/powerpoint/2010/main" val="19466879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ENGAGE" val="{&quot;SavedSwatch&quot;:&quot;-14272694|-12223080|-16154294|-9539986|-16777216|Fisheries and Oceans Canada&quot;,&quot;Id&quot;:&quot;671695c44542453258e43579&quot;,&quot;SmartGridHorizontal&quot;:0,&quot;LinkedExcelSources&quot;:{},&quot;LinkedProjectSources&quot;:{},&quot;FlowConfig&quot;:{&quot;Canvas&quot;:{&quot;Slide&quot;:-1,&quot;Width&quot;:0,&quot;Height&quot;:0},&quot;Timeline&quot;:{&quot;Actions&quot;:[]}},&quot;LinkedSlideMergeSources&quot;:{},&quot;LinkedSharePointSlideMergeSources&quot;:{}}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279</TotalTime>
  <Words>320</Words>
  <Application>Microsoft Office PowerPoint</Application>
  <PresentationFormat>Custom</PresentationFormat>
  <Paragraphs>1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MinionPro-Bold</vt:lpstr>
      <vt:lpstr>Palatino Linotype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outhier, Sharon (DFO/MPO)</dc:creator>
  <cp:lastModifiedBy>Clouthier, Sharon (DFO/MPO)</cp:lastModifiedBy>
  <cp:revision>20</cp:revision>
  <dcterms:created xsi:type="dcterms:W3CDTF">2024-09-21T19:04:35Z</dcterms:created>
  <dcterms:modified xsi:type="dcterms:W3CDTF">2025-04-04T14:25:12Z</dcterms:modified>
</cp:coreProperties>
</file>